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7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3A83E2-9D3B-4C1E-AF51-5EAF0F72E94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785B53C-E880-4646-8649-54820E98002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ACC44E-858A-4A38-9F47-E2C463B2B6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F5C3C0-0157-4DC7-8BDA-0F670B66E8BD}" type="datetimeFigureOut">
              <a:rPr lang="en-US" smtClean="0"/>
              <a:t>4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9EC32F-B17B-4465-9E5F-8C423450F0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2C4271-DCB0-4301-B04B-CDA2A30CD0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C442FA-017E-4D2E-B890-DA3C9DE61F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71403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30D0F1-7A74-49D6-A720-0FA87C34C8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EAECAF1-77E3-4A10-97F2-4CB0F8EE374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B4EF7D-B8DF-4A83-9E94-B00D6D9F3A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F5C3C0-0157-4DC7-8BDA-0F670B66E8BD}" type="datetimeFigureOut">
              <a:rPr lang="en-US" smtClean="0"/>
              <a:t>4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7A6F56-6D91-44E8-82E4-055E91336C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3937D8-D355-4295-A6B4-616F7FA232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C442FA-017E-4D2E-B890-DA3C9DE61F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52968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8896AB7-A4B8-40DD-A481-B5A6D20C882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BAE3078-0ABB-410D-BBD2-F9D7546A12E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45164C-8B0A-42C9-8FF0-C97A4D223B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F5C3C0-0157-4DC7-8BDA-0F670B66E8BD}" type="datetimeFigureOut">
              <a:rPr lang="en-US" smtClean="0"/>
              <a:t>4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9EA4C0-4F55-40C0-9FE0-F2902D3D93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AD37B1-571D-4605-8FBA-AECE45B0B0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C442FA-017E-4D2E-B890-DA3C9DE61F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50425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4AF1F8-2633-4B74-83B6-B7994B031C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1FF574B-7351-404A-9D97-ABC19698577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3177BA-2D33-4545-857F-227937FCC0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F5C3C0-0157-4DC7-8BDA-0F670B66E8BD}" type="datetimeFigureOut">
              <a:rPr lang="en-US" smtClean="0"/>
              <a:t>4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FFDD25-A5E9-411F-BB6A-891F0045F1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5C2C55-44D6-44C0-927B-94BEC6A99B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C442FA-017E-4D2E-B890-DA3C9DE61F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89278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93A93D-C64F-4D97-86D1-205706A951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7FA9F27-573E-4BCE-978D-19629BFA19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34983A-1A88-4C03-A94B-BBB50BD9CE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F5C3C0-0157-4DC7-8BDA-0F670B66E8BD}" type="datetimeFigureOut">
              <a:rPr lang="en-US" smtClean="0"/>
              <a:t>4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98D091-8657-460E-99B4-7E0A2C6EA2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C469CD-0B23-4C97-9F86-128D573C20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C442FA-017E-4D2E-B890-DA3C9DE61F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7241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3D5048-B035-4DB3-A4B9-3ADD360457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C3696CC-5808-4484-B691-86E42A930F5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6185774-D410-49AD-BDC3-FA2D4E253B1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C389960-0A9D-47FC-B02B-E288B973DF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F5C3C0-0157-4DC7-8BDA-0F670B66E8BD}" type="datetimeFigureOut">
              <a:rPr lang="en-US" smtClean="0"/>
              <a:t>4/18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2341324-6078-4C04-954C-50D3C96C20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AFED063-D010-4FE1-B6FA-983FDE6F99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C442FA-017E-4D2E-B890-DA3C9DE61F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62515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67902A-E2EC-43EE-BB9D-733C162A4D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C9F41A0-0E09-4FFC-9A7E-6E4B3282BD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D9BCB20-2280-48A0-820B-70A0F0098BA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25E83BD-D943-4D84-948B-7BA9789EED6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146B6D3-9EC2-40D6-B8E6-4C9DBC52812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0660CFC-D8A6-4CE0-9361-CD575A3C45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F5C3C0-0157-4DC7-8BDA-0F670B66E8BD}" type="datetimeFigureOut">
              <a:rPr lang="en-US" smtClean="0"/>
              <a:t>4/18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9F1ED40-73E2-422F-ACAE-A0D98C7367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A41015B-2794-449D-A7A3-43A1E272A0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C442FA-017E-4D2E-B890-DA3C9DE61F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49651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D383A8-DEA4-4540-8E0B-CB6FEEA923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9EAFC10-7B7E-440B-8533-E060847CF9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F5C3C0-0157-4DC7-8BDA-0F670B66E8BD}" type="datetimeFigureOut">
              <a:rPr lang="en-US" smtClean="0"/>
              <a:t>4/18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670314A-A2F4-4688-9B5D-027D31D5FC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4FCFB31-8731-46AF-AA7B-019DEFA250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C442FA-017E-4D2E-B890-DA3C9DE61F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56862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92C51D4-068B-4E20-8C21-656C8BE3BD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F5C3C0-0157-4DC7-8BDA-0F670B66E8BD}" type="datetimeFigureOut">
              <a:rPr lang="en-US" smtClean="0"/>
              <a:t>4/18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1808BD1-43F2-481F-A191-0AE98EC77C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E8FB0D8-4872-4B68-ACDB-2EF57CA3A3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C442FA-017E-4D2E-B890-DA3C9DE61F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54826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A732D3-8E70-48FA-8838-AA12380CC1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21EC6BB-4319-4378-8DE9-7E698023F40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A35E005-1D29-46CF-8F02-975B2F4BA23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AF93E36-EACA-4484-B74C-4FCAACAAE8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F5C3C0-0157-4DC7-8BDA-0F670B66E8BD}" type="datetimeFigureOut">
              <a:rPr lang="en-US" smtClean="0"/>
              <a:t>4/18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39C61EE-5C2B-4B44-866E-F57CA7290D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24DC4A5-1931-42CA-A167-39126B8690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C442FA-017E-4D2E-B890-DA3C9DE61F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68118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900E31-7AA9-4833-B523-6A6F77BE0B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B10416B-7646-4FD2-9977-D03D92ECD3F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31015D0-2D89-4FE4-8E98-E523FD86BC3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9A75B24-B7B5-4089-A3AD-73B37D460D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F5C3C0-0157-4DC7-8BDA-0F670B66E8BD}" type="datetimeFigureOut">
              <a:rPr lang="en-US" smtClean="0"/>
              <a:t>4/18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B924769-36EB-4081-B5A3-5DB8585F6D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096D7D3-4715-482E-A6CF-43F800215F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C442FA-017E-4D2E-B890-DA3C9DE61F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75160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65F52AA-D228-4074-900E-A8C88AE4E7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967DAA3-BA82-45A7-A4F4-06F823CA91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97B7B0-FBA0-4EF4-AE31-43BB77AA707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F5C3C0-0157-4DC7-8BDA-0F670B66E8BD}" type="datetimeFigureOut">
              <a:rPr lang="en-US" smtClean="0"/>
              <a:t>4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84330E-2188-4919-9D31-0FD9DAF957D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76C439-5998-4EF0-9135-135CF80504F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C442FA-017E-4D2E-B890-DA3C9DE61F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22554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908D2C01-3CF0-4D82-AF2D-2EDEEAD7F058}"/>
              </a:ext>
            </a:extLst>
          </p:cNvPr>
          <p:cNvSpPr txBox="1"/>
          <p:nvPr/>
        </p:nvSpPr>
        <p:spPr>
          <a:xfrm>
            <a:off x="3808429" y="5099901"/>
            <a:ext cx="40252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grpSp>
        <p:nvGrpSpPr>
          <p:cNvPr id="23" name="Group 22">
            <a:extLst>
              <a:ext uri="{FF2B5EF4-FFF2-40B4-BE49-F238E27FC236}">
                <a16:creationId xmlns:a16="http://schemas.microsoft.com/office/drawing/2014/main" id="{BCC81F9A-F0E9-4D14-ABAC-D7558107CC2B}"/>
              </a:ext>
            </a:extLst>
          </p:cNvPr>
          <p:cNvGrpSpPr/>
          <p:nvPr/>
        </p:nvGrpSpPr>
        <p:grpSpPr>
          <a:xfrm>
            <a:off x="829980" y="1634254"/>
            <a:ext cx="3484833" cy="3322961"/>
            <a:chOff x="649016" y="719686"/>
            <a:chExt cx="3484833" cy="3322961"/>
          </a:xfrm>
        </p:grpSpPr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27FCAD7F-D3F6-4764-9F23-221E533E0FE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r="11871" b="23108"/>
            <a:stretch/>
          </p:blipFill>
          <p:spPr>
            <a:xfrm>
              <a:off x="723900" y="719686"/>
              <a:ext cx="3409949" cy="3322961"/>
            </a:xfrm>
            <a:prstGeom prst="rect">
              <a:avLst/>
            </a:prstGeom>
          </p:spPr>
        </p:pic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9910C5EE-688D-4BC4-A1B9-1EB058100D74}"/>
                </a:ext>
              </a:extLst>
            </p:cNvPr>
            <p:cNvSpPr txBox="1"/>
            <p:nvPr/>
          </p:nvSpPr>
          <p:spPr>
            <a:xfrm>
              <a:off x="2379529" y="1382521"/>
              <a:ext cx="104038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SimSun" panose="02010600030101010101" pitchFamily="2" charset="-122"/>
                  <a:cs typeface="Palatino Linotype" panose="02040502050505030304" pitchFamily="18" charset="0"/>
                </a:rPr>
                <a:t>OM004573</a:t>
              </a:r>
              <a:endParaRPr lang="en-US" sz="1200" dirty="0"/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0A08FCF8-7C30-4E66-8B5D-0CBA3905BA09}"/>
                </a:ext>
              </a:extLst>
            </p:cNvPr>
            <p:cNvSpPr txBox="1"/>
            <p:nvPr/>
          </p:nvSpPr>
          <p:spPr>
            <a:xfrm>
              <a:off x="1589324" y="912604"/>
              <a:ext cx="104038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SimSun" panose="02010600030101010101" pitchFamily="2" charset="-122"/>
                  <a:cs typeface="Palatino Linotype" panose="02040502050505030304" pitchFamily="18" charset="0"/>
                </a:rPr>
                <a:t>OM004575</a:t>
              </a:r>
              <a:endParaRPr lang="en-US" sz="1200" dirty="0"/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3AA09EF8-8204-49B9-BD01-1B3D262F15CA}"/>
                </a:ext>
              </a:extLst>
            </p:cNvPr>
            <p:cNvSpPr txBox="1"/>
            <p:nvPr/>
          </p:nvSpPr>
          <p:spPr>
            <a:xfrm>
              <a:off x="1496996" y="1614801"/>
              <a:ext cx="104038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SimSun" panose="02010600030101010101" pitchFamily="2" charset="-122"/>
                  <a:cs typeface="Palatino Linotype" panose="02040502050505030304" pitchFamily="18" charset="0"/>
                </a:rPr>
                <a:t>OM004639</a:t>
              </a:r>
              <a:endParaRPr lang="en-US" sz="1200" dirty="0"/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A7ACF8BE-A2A9-4F48-878A-84D44F76AD02}"/>
                </a:ext>
              </a:extLst>
            </p:cNvPr>
            <p:cNvSpPr txBox="1"/>
            <p:nvPr/>
          </p:nvSpPr>
          <p:spPr>
            <a:xfrm>
              <a:off x="649016" y="3152001"/>
              <a:ext cx="104038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SimSun" panose="02010600030101010101" pitchFamily="2" charset="-122"/>
                  <a:cs typeface="Palatino Linotype" panose="02040502050505030304" pitchFamily="18" charset="0"/>
                </a:rPr>
                <a:t>OM004633</a:t>
              </a:r>
              <a:endParaRPr lang="en-US" sz="1200" dirty="0"/>
            </a:p>
          </p:txBody>
        </p:sp>
      </p:grpSp>
      <p:grpSp>
        <p:nvGrpSpPr>
          <p:cNvPr id="31" name="Group 30">
            <a:extLst>
              <a:ext uri="{FF2B5EF4-FFF2-40B4-BE49-F238E27FC236}">
                <a16:creationId xmlns:a16="http://schemas.microsoft.com/office/drawing/2014/main" id="{7ECCD636-889C-426E-8759-32AEEEE3F433}"/>
              </a:ext>
            </a:extLst>
          </p:cNvPr>
          <p:cNvGrpSpPr/>
          <p:nvPr/>
        </p:nvGrpSpPr>
        <p:grpSpPr>
          <a:xfrm>
            <a:off x="5782984" y="1310953"/>
            <a:ext cx="5487881" cy="4782090"/>
            <a:chOff x="5429185" y="1357302"/>
            <a:chExt cx="5487881" cy="4782090"/>
          </a:xfrm>
        </p:grpSpPr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57B2FFC0-70A4-4286-9168-04143FF8A65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23200" r="15290" b="7778"/>
            <a:stretch/>
          </p:blipFill>
          <p:spPr>
            <a:xfrm>
              <a:off x="5429185" y="1357302"/>
              <a:ext cx="5487881" cy="4782090"/>
            </a:xfrm>
            <a:prstGeom prst="rect">
              <a:avLst/>
            </a:prstGeom>
          </p:spPr>
        </p:pic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9598BE38-42A8-4F48-A0F4-8DC95EF44D4B}"/>
                </a:ext>
              </a:extLst>
            </p:cNvPr>
            <p:cNvSpPr txBox="1"/>
            <p:nvPr/>
          </p:nvSpPr>
          <p:spPr>
            <a:xfrm>
              <a:off x="9038460" y="4565015"/>
              <a:ext cx="104038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SimSun" panose="02010600030101010101" pitchFamily="2" charset="-122"/>
                  <a:cs typeface="Palatino Linotype" panose="02040502050505030304" pitchFamily="18" charset="0"/>
                </a:rPr>
                <a:t>OM004573</a:t>
              </a:r>
              <a:endParaRPr lang="en-US" sz="1200" dirty="0"/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14297A1C-932F-4AF4-9D40-F82DFD768D93}"/>
                </a:ext>
              </a:extLst>
            </p:cNvPr>
            <p:cNvSpPr txBox="1"/>
            <p:nvPr/>
          </p:nvSpPr>
          <p:spPr>
            <a:xfrm>
              <a:off x="8408510" y="3859428"/>
              <a:ext cx="104038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SimSun" panose="02010600030101010101" pitchFamily="2" charset="-122"/>
                  <a:cs typeface="Palatino Linotype" panose="02040502050505030304" pitchFamily="18" charset="0"/>
                </a:rPr>
                <a:t>OM004575</a:t>
              </a:r>
              <a:endParaRPr lang="en-US" sz="1200" dirty="0"/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97244C85-387B-4279-81D3-3A58BBEA6238}"/>
                </a:ext>
              </a:extLst>
            </p:cNvPr>
            <p:cNvSpPr txBox="1"/>
            <p:nvPr/>
          </p:nvSpPr>
          <p:spPr>
            <a:xfrm>
              <a:off x="7273430" y="3859428"/>
              <a:ext cx="104038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SimSun" panose="02010600030101010101" pitchFamily="2" charset="-122"/>
                  <a:cs typeface="Palatino Linotype" panose="02040502050505030304" pitchFamily="18" charset="0"/>
                </a:rPr>
                <a:t>OM004639</a:t>
              </a:r>
              <a:endParaRPr lang="en-US" sz="1200" dirty="0"/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66F38364-9EC2-473D-AAC0-3C0CE652E55A}"/>
                </a:ext>
              </a:extLst>
            </p:cNvPr>
            <p:cNvSpPr txBox="1"/>
            <p:nvPr/>
          </p:nvSpPr>
          <p:spPr>
            <a:xfrm>
              <a:off x="6332854" y="4402987"/>
              <a:ext cx="104038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SimSun" panose="02010600030101010101" pitchFamily="2" charset="-122"/>
                  <a:cs typeface="Palatino Linotype" panose="02040502050505030304" pitchFamily="18" charset="0"/>
                </a:rPr>
                <a:t>OM004639</a:t>
              </a:r>
              <a:endParaRPr lang="en-US" sz="1200" dirty="0"/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5B6E4201-E7EF-4C67-8265-36FD8580069B}"/>
              </a:ext>
            </a:extLst>
          </p:cNvPr>
          <p:cNvSpPr txBox="1"/>
          <p:nvPr/>
        </p:nvSpPr>
        <p:spPr>
          <a:xfrm>
            <a:off x="653770" y="141402"/>
            <a:ext cx="11242857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igure S1</a:t>
            </a:r>
            <a:r>
              <a:rPr lang="en-US" sz="1400" dirty="0"/>
              <a:t> Neighbor joining tree and multidimensional scaling based on sequences of 169 accessions from seven </a:t>
            </a:r>
            <a:r>
              <a:rPr lang="en-US" sz="1400" i="1" dirty="0" err="1"/>
              <a:t>Avena</a:t>
            </a:r>
            <a:r>
              <a:rPr lang="en-US" sz="1400" dirty="0"/>
              <a:t> species. Each species was represented by 4-49 accessions. The phylogenetic tree was constructed in MEGA X using the pairwise genetic distance matrix, while the multidimensional scaling plot was plotted using </a:t>
            </a:r>
            <a:r>
              <a:rPr lang="en-US" sz="1400" dirty="0" err="1"/>
              <a:t>CurlyWhirly</a:t>
            </a:r>
            <a:r>
              <a:rPr lang="en-US" sz="1400" dirty="0"/>
              <a:t> v1.19.09.04. Font colors are as follows:  </a:t>
            </a:r>
            <a:r>
              <a:rPr lang="en-US" sz="1400" i="1" dirty="0"/>
              <a:t>A. </a:t>
            </a:r>
            <a:r>
              <a:rPr lang="en-US" sz="1400" i="1" dirty="0" err="1"/>
              <a:t>canariensis</a:t>
            </a:r>
            <a:r>
              <a:rPr lang="en-US" sz="1400" dirty="0"/>
              <a:t> (green), </a:t>
            </a:r>
            <a:r>
              <a:rPr lang="en-US" sz="1400" i="1" dirty="0"/>
              <a:t>A. </a:t>
            </a:r>
            <a:r>
              <a:rPr lang="en-US" sz="1400" i="1" dirty="0" err="1"/>
              <a:t>damascena</a:t>
            </a:r>
            <a:r>
              <a:rPr lang="en-US" sz="1400" dirty="0"/>
              <a:t> (pink), </a:t>
            </a:r>
            <a:r>
              <a:rPr lang="en-US" sz="1400" i="1" dirty="0"/>
              <a:t>A. </a:t>
            </a:r>
            <a:r>
              <a:rPr lang="en-US" sz="1400" i="1" dirty="0" err="1"/>
              <a:t>longiglumis</a:t>
            </a:r>
            <a:r>
              <a:rPr lang="en-US" sz="1400" dirty="0"/>
              <a:t> (purple), </a:t>
            </a:r>
            <a:r>
              <a:rPr lang="en-US" sz="1400" i="1" dirty="0"/>
              <a:t>A. </a:t>
            </a:r>
            <a:r>
              <a:rPr lang="en-US" sz="1400" i="1" dirty="0" err="1"/>
              <a:t>prostrata</a:t>
            </a:r>
            <a:r>
              <a:rPr lang="en-US" sz="1400" dirty="0"/>
              <a:t> (Olive), </a:t>
            </a:r>
            <a:r>
              <a:rPr lang="en-US" sz="1400" i="1" dirty="0"/>
              <a:t>A. </a:t>
            </a:r>
            <a:r>
              <a:rPr lang="en-US" sz="1400" i="1" dirty="0" err="1"/>
              <a:t>atlantica</a:t>
            </a:r>
            <a:r>
              <a:rPr lang="en-US" sz="1400" dirty="0"/>
              <a:t> (red), </a:t>
            </a:r>
            <a:r>
              <a:rPr lang="en-US" sz="1400" i="1" dirty="0"/>
              <a:t>A. </a:t>
            </a:r>
            <a:r>
              <a:rPr lang="en-US" sz="1400" i="1" dirty="0" err="1"/>
              <a:t>hirtula</a:t>
            </a:r>
            <a:r>
              <a:rPr lang="en-US" sz="1400" dirty="0"/>
              <a:t> (Black), and </a:t>
            </a:r>
            <a:r>
              <a:rPr lang="en-US" sz="1400" i="1" dirty="0"/>
              <a:t>A. </a:t>
            </a:r>
            <a:r>
              <a:rPr lang="en-US" sz="1400" i="1" dirty="0" err="1"/>
              <a:t>wiestii</a:t>
            </a:r>
            <a:r>
              <a:rPr lang="en-US" sz="1400" dirty="0"/>
              <a:t> (Orange).</a:t>
            </a:r>
          </a:p>
          <a:p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12097858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8</TotalTime>
  <Words>110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S</dc:creator>
  <cp:lastModifiedBy>MDPI</cp:lastModifiedBy>
  <cp:revision>20</cp:revision>
  <dcterms:created xsi:type="dcterms:W3CDTF">2022-03-16T16:22:22Z</dcterms:created>
  <dcterms:modified xsi:type="dcterms:W3CDTF">2022-04-18T04:14:10Z</dcterms:modified>
</cp:coreProperties>
</file>